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  <p:sldId id="256" r:id="rId3"/>
    <p:sldId id="257" r:id="rId4"/>
    <p:sldId id="269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85"/>
  </p:normalViewPr>
  <p:slideViewPr>
    <p:cSldViewPr snapToGrid="0" snapToObjects="1">
      <p:cViewPr varScale="1">
        <p:scale>
          <a:sx n="81" d="100"/>
          <a:sy n="81" d="100"/>
        </p:scale>
        <p:origin x="72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265C20-8ABA-7D47-B49E-B21CCECDB33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7489C5-4E80-5645-B6D4-52E1743D48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5DE10B-FDF2-ED48-8325-C99EFE5F3C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C7EA5-8B52-7249-B1F7-634335AAFA4A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A6AFFE-8B43-6142-9B36-34D2FC7CD8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27DE71-9EAE-314C-A8B8-972F46B711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D7F2E-7C03-5545-BADF-E8E90BCC5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887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D5471F-22E9-7E47-B322-02AE56A744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A7604C-3E27-F547-8F59-EF168DFB16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E19A7D-91DF-4341-B11F-477F0F0C20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C7EA5-8B52-7249-B1F7-634335AAFA4A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843629-6427-5249-9141-8E9E7055A5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DA923B-9F20-C44F-A452-8E1DFCFDA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D7F2E-7C03-5545-BADF-E8E90BCC5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416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794429C-7213-1949-9E70-969243F24C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13CD44-7239-5743-ACB2-DD89B3AC86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EFE80C-94A8-BD4E-9237-322A6CD5C9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C7EA5-8B52-7249-B1F7-634335AAFA4A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F4F20E-C6B6-AE44-85A8-2ECC455BD7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9F66A8-6B2C-C042-87DE-ECD3E33C3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D7F2E-7C03-5545-BADF-E8E90BCC5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29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D3E3A8-4C49-7348-AB55-482C812AD9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2AD0B7-0BCB-8948-B4A9-5A4ABB187E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412E6D-E07B-BE41-86E2-68107AE0D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C7EA5-8B52-7249-B1F7-634335AAFA4A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094CEB-216F-5B42-A296-480A9F3B1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DED356-240F-B246-ACF4-29B504FBE4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D7F2E-7C03-5545-BADF-E8E90BCC5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719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848494-12AA-1C4A-930D-6B69909939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A3F4EB-A312-3744-8997-2FAF1EB9E2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67968F-32D3-604D-83E8-7A4EBB9C3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C7EA5-8B52-7249-B1F7-634335AAFA4A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47A2AB-31F9-274A-B227-6B97E547D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A39698-F4B4-084D-9A9B-0D4821A04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D7F2E-7C03-5545-BADF-E8E90BCC5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15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FCDC85-03E0-F64D-BDA0-AA942CEE83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6E3016-C0DE-E540-A8C6-5C17A9EFC8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1FA09BC-2A22-9B49-985D-08541EB621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7086A0-93F4-E44E-BE0C-ADAAF4C1A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C7EA5-8B52-7249-B1F7-634335AAFA4A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D37AF9-7174-6444-9A2B-BB3F07E3D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34E675-CA8A-1A4C-98A9-3C339AA20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D7F2E-7C03-5545-BADF-E8E90BCC5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525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117D15-933A-E54E-A9BA-6470B45DE9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71D62C-B4A7-3A4E-9008-D62F38B67E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4F4DE8-05AC-1843-B7DC-80D0D73422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E6C9015-2519-FD4C-9FE4-74D35134E7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B79EED-D58E-424F-AB55-70F13FA433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10AC2E5-7690-1C4D-B26A-638B04F9DE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C7EA5-8B52-7249-B1F7-634335AAFA4A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F4C5A18-3429-E24B-AE3B-E7BF5CF223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F828708-9B7E-F84B-958C-B406AADFA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D7F2E-7C03-5545-BADF-E8E90BCC5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893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F7BDF7-ABB3-7F4B-813E-560ED02043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B00ABF-00C4-E64F-91A9-45422C65C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C7EA5-8B52-7249-B1F7-634335AAFA4A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07EC85-1750-5741-9AAA-8184457214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BA049C7-35AE-3F4B-B563-89B0D50D0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D7F2E-7C03-5545-BADF-E8E90BCC5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154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538DAE3-3A5A-5B4C-8F21-10EDA75CB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C7EA5-8B52-7249-B1F7-634335AAFA4A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A97F738-A3FA-D94D-A725-256D6A90D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F7927F-CDAC-DB43-A5E2-7F554FA43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D7F2E-7C03-5545-BADF-E8E90BCC5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432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2AA481-76E3-A242-ACC8-871419D688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939824-C74D-A44C-9782-C5CD07F7F0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9903DE-920E-C84C-AD6D-5457BA10C1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1F4D49-1558-4A43-840A-73C24A23C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C7EA5-8B52-7249-B1F7-634335AAFA4A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115963-7BBA-BC4E-B472-C8DB81F49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EF2BAA-FD99-6B4F-AC71-7514ABC55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D7F2E-7C03-5545-BADF-E8E90BCC5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529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70D766-9678-9F4F-99F1-CBA31AD923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FB74772-F513-544F-8574-DFFBE597045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F608F0-1787-E144-95E0-02F4FA35E5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85ED22-3361-B84D-A869-2D90A68C71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C7EA5-8B52-7249-B1F7-634335AAFA4A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0B0BFC-2318-0045-BC49-F873E7CF54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CD346C-0097-9845-B555-0D08AC4A81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D7F2E-7C03-5545-BADF-E8E90BCC5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657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EE15723-40F3-1747-B1D2-BC272D8017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332F43-5853-EB4F-BB19-381F1C9BE2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81DF66-8004-8B40-93FE-8395D3649D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C7EA5-8B52-7249-B1F7-634335AAFA4A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418EC0-B627-E742-B41E-E52F9C04A9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189994-0D2E-D544-9AB1-8F6E9E307C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ED7F2E-7C03-5545-BADF-E8E90BCC5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57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9E3C56CE-41DB-CC49-9132-B812D142AC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" y="216817"/>
            <a:ext cx="12191999" cy="3987538"/>
          </a:xfrm>
        </p:spPr>
        <p:txBody>
          <a:bodyPr>
            <a:normAutofit/>
          </a:bodyPr>
          <a:lstStyle/>
          <a:p>
            <a:pPr algn="just"/>
            <a:r>
              <a:rPr lang="en-US" b="1" dirty="0"/>
              <a:t>Figures S3A to S3M</a:t>
            </a:r>
            <a:r>
              <a:rPr lang="en-US" dirty="0"/>
              <a:t> show alignments of genomic sequence reads versus the complete reference genome sequence of </a:t>
            </a:r>
            <a:r>
              <a:rPr lang="en-US" i="1" dirty="0"/>
              <a:t>Xanthomonas </a:t>
            </a:r>
            <a:r>
              <a:rPr lang="en-US" i="1" dirty="0" err="1"/>
              <a:t>vasicola</a:t>
            </a:r>
            <a:r>
              <a:rPr lang="en-US" i="1" dirty="0"/>
              <a:t> </a:t>
            </a:r>
            <a:r>
              <a:rPr lang="en-US" dirty="0" err="1"/>
              <a:t>pv</a:t>
            </a:r>
            <a:r>
              <a:rPr lang="en-US" dirty="0"/>
              <a:t>. </a:t>
            </a:r>
            <a:r>
              <a:rPr lang="en-US" i="1" dirty="0" err="1"/>
              <a:t>musacearum</a:t>
            </a:r>
            <a:r>
              <a:rPr lang="en-US" dirty="0"/>
              <a:t> NCPPB 4379 (GenBank: CP034655.1). Reads were aligned using BWA-mem and visualized using IGV.</a:t>
            </a:r>
            <a:endParaRPr lang="en-US" b="1" dirty="0"/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F1A7EE-600F-4049-9C44-0F2A5D66E6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" y="4621490"/>
            <a:ext cx="12191998" cy="1859437"/>
          </a:xfrm>
        </p:spPr>
        <p:txBody>
          <a:bodyPr>
            <a:normAutofit lnSpcReduction="10000"/>
          </a:bodyPr>
          <a:lstStyle/>
          <a:p>
            <a:r>
              <a:rPr lang="en-US" sz="2400" dirty="0"/>
              <a:t>﻿﻿Li, H., and Durbin, R. (2009). Fast and accurate short read alignment with Burrows-Wheeler transform. Bioinformatics 25, 1754–1760. </a:t>
            </a:r>
            <a:r>
              <a:rPr lang="en-US" sz="2400" dirty="0" err="1"/>
              <a:t>doi</a:t>
            </a:r>
            <a:r>
              <a:rPr lang="en-US" sz="2400" dirty="0"/>
              <a:t>: 10.1093/bioinformatics/btp324</a:t>
            </a:r>
          </a:p>
          <a:p>
            <a:r>
              <a:rPr lang="en-US" sz="2400" dirty="0"/>
              <a:t>﻿Thorvaldsdóttir, H., Robinson, J. T., and </a:t>
            </a:r>
            <a:r>
              <a:rPr lang="en-US" sz="2400" dirty="0" err="1"/>
              <a:t>Mesirov</a:t>
            </a:r>
            <a:r>
              <a:rPr lang="en-US" sz="2400" dirty="0"/>
              <a:t>, J. P. (2013). Integrative Genomics Viewer (IGV): high-performance genomics data visualization and exploration. Briefings </a:t>
            </a:r>
            <a:r>
              <a:rPr lang="en-US" sz="2400" dirty="0" err="1"/>
              <a:t>Bioinforma</a:t>
            </a:r>
            <a:r>
              <a:rPr lang="en-US" sz="2400" dirty="0"/>
              <a:t>. 14, 178–192. </a:t>
            </a:r>
            <a:r>
              <a:rPr lang="en-US" sz="2400" dirty="0" err="1"/>
              <a:t>doi</a:t>
            </a:r>
            <a:r>
              <a:rPr lang="en-US" sz="2400" dirty="0"/>
              <a:t>: 10.1093/bib/bbs017</a:t>
            </a:r>
          </a:p>
        </p:txBody>
      </p:sp>
    </p:spTree>
    <p:extLst>
      <p:ext uri="{BB962C8B-B14F-4D97-AF65-F5344CB8AC3E}">
        <p14:creationId xmlns:p14="http://schemas.microsoft.com/office/powerpoint/2010/main" val="2987448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6526041C-0483-2A4E-A15D-03400438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I. A SNP in </a:t>
            </a:r>
            <a:r>
              <a:rPr lang="en-US" i="1" dirty="0" err="1"/>
              <a:t>xopAE</a:t>
            </a:r>
            <a:r>
              <a:rPr lang="en-US" dirty="0"/>
              <a:t>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C21220D-A851-E840-AFC4-7FF005898C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6286" y="1771277"/>
            <a:ext cx="11479427" cy="4721598"/>
          </a:xfrm>
          <a:prstGeom prst="rect">
            <a:avLst/>
          </a:prstGeom>
        </p:spPr>
      </p:pic>
      <p:sp>
        <p:nvSpPr>
          <p:cNvPr id="6" name="Oval 5">
            <a:extLst>
              <a:ext uri="{FF2B5EF4-FFF2-40B4-BE49-F238E27FC236}">
                <a16:creationId xmlns:a16="http://schemas.microsoft.com/office/drawing/2014/main" id="{738A3721-9629-2945-B7F2-5F66034125A8}"/>
              </a:ext>
            </a:extLst>
          </p:cNvPr>
          <p:cNvSpPr/>
          <p:nvPr/>
        </p:nvSpPr>
        <p:spPr>
          <a:xfrm>
            <a:off x="6248399" y="3548744"/>
            <a:ext cx="533400" cy="58782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16968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6526041C-0483-2A4E-A15D-03400438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J. A SNP in </a:t>
            </a:r>
            <a:r>
              <a:rPr lang="en-US" i="1" dirty="0"/>
              <a:t>xopAF2</a:t>
            </a:r>
            <a:r>
              <a:rPr lang="en-US" dirty="0"/>
              <a:t>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4AB1AF2-9265-714D-8DFF-79697C82F2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708" y="1690688"/>
            <a:ext cx="11675360" cy="4802187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C8CE7B09-5612-2145-A733-F106D07ADDD3}"/>
              </a:ext>
            </a:extLst>
          </p:cNvPr>
          <p:cNvSpPr/>
          <p:nvPr/>
        </p:nvSpPr>
        <p:spPr>
          <a:xfrm>
            <a:off x="6455228" y="3690258"/>
            <a:ext cx="533400" cy="58782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65937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6526041C-0483-2A4E-A15D-03400438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K. Two SNPs in </a:t>
            </a:r>
            <a:r>
              <a:rPr lang="en-US" i="1" dirty="0" err="1"/>
              <a:t>xopAG</a:t>
            </a:r>
            <a:r>
              <a:rPr lang="en-US" dirty="0"/>
              <a:t>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BFC4D52-D87F-E044-BD5B-42C6F11E09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2146" y="1690688"/>
            <a:ext cx="11675360" cy="4802187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5B1C4D2D-2A06-414D-ACA4-F6C67A4927F9}"/>
              </a:ext>
            </a:extLst>
          </p:cNvPr>
          <p:cNvSpPr/>
          <p:nvPr/>
        </p:nvSpPr>
        <p:spPr>
          <a:xfrm>
            <a:off x="11234055" y="2536370"/>
            <a:ext cx="533400" cy="58782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25CD4FE2-CFC3-D648-9CCF-27C1A1C31B05}"/>
              </a:ext>
            </a:extLst>
          </p:cNvPr>
          <p:cNvSpPr/>
          <p:nvPr/>
        </p:nvSpPr>
        <p:spPr>
          <a:xfrm>
            <a:off x="1796149" y="2743202"/>
            <a:ext cx="533400" cy="914398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5343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6526041C-0483-2A4E-A15D-03400438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L. Four of five SNPs in </a:t>
            </a:r>
            <a:r>
              <a:rPr lang="en-US" i="1" dirty="0" err="1"/>
              <a:t>xopP</a:t>
            </a:r>
            <a:r>
              <a:rPr lang="en-US" dirty="0"/>
              <a:t>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3551340-089C-724A-B477-14484B2A61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919" y="1862761"/>
            <a:ext cx="11257005" cy="4630114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21989055-83D2-0542-83C0-64DDD5B9A4E4}"/>
              </a:ext>
            </a:extLst>
          </p:cNvPr>
          <p:cNvSpPr/>
          <p:nvPr/>
        </p:nvSpPr>
        <p:spPr>
          <a:xfrm>
            <a:off x="1719942" y="2743199"/>
            <a:ext cx="1502229" cy="1556658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9872C85B-97E8-4443-B79D-D2293669C8F3}"/>
              </a:ext>
            </a:extLst>
          </p:cNvPr>
          <p:cNvSpPr/>
          <p:nvPr/>
        </p:nvSpPr>
        <p:spPr>
          <a:xfrm>
            <a:off x="4615537" y="2808511"/>
            <a:ext cx="1502229" cy="1360720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91CB363C-A876-1E4E-ADC4-B18EE84ECAE2}"/>
              </a:ext>
            </a:extLst>
          </p:cNvPr>
          <p:cNvSpPr/>
          <p:nvPr/>
        </p:nvSpPr>
        <p:spPr>
          <a:xfrm>
            <a:off x="10776857" y="2797623"/>
            <a:ext cx="653143" cy="1360720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93454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6526041C-0483-2A4E-A15D-03400438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M. One of five SNPs in </a:t>
            </a:r>
            <a:r>
              <a:rPr lang="en-US" i="1" dirty="0" err="1"/>
              <a:t>xopP</a:t>
            </a:r>
            <a:r>
              <a:rPr lang="en-US" dirty="0"/>
              <a:t>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51DCD41-D2F9-E54F-8DB6-CB584E2504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2145" y="1690688"/>
            <a:ext cx="11419703" cy="4697033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DC3EC7FD-2146-FC45-BC23-0B62D7B6E03E}"/>
              </a:ext>
            </a:extLst>
          </p:cNvPr>
          <p:cNvSpPr/>
          <p:nvPr/>
        </p:nvSpPr>
        <p:spPr>
          <a:xfrm>
            <a:off x="6008914" y="3875314"/>
            <a:ext cx="762000" cy="914400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9887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5F1E682-90F7-DA4A-A15A-A896D0412D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3632" y="1844049"/>
            <a:ext cx="11121081" cy="4574207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:a16="http://schemas.microsoft.com/office/drawing/2014/main" id="{6526041C-0483-2A4E-A15D-03400438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A. SNP in </a:t>
            </a:r>
            <a:r>
              <a:rPr lang="en-US" i="1" dirty="0"/>
              <a:t>xopF1</a:t>
            </a:r>
            <a:r>
              <a:rPr lang="en-US" dirty="0"/>
              <a:t>.</a:t>
            </a:r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76A9F5CD-1BAE-5541-A3C8-1CF8A72F8EE6}"/>
              </a:ext>
            </a:extLst>
          </p:cNvPr>
          <p:cNvSpPr/>
          <p:nvPr/>
        </p:nvSpPr>
        <p:spPr>
          <a:xfrm>
            <a:off x="6281057" y="2579914"/>
            <a:ext cx="533400" cy="58782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8532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6526041C-0483-2A4E-A15D-03400438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B. SNP in </a:t>
            </a:r>
            <a:r>
              <a:rPr lang="en-US" i="1" dirty="0" err="1"/>
              <a:t>xopK</a:t>
            </a:r>
            <a:r>
              <a:rPr lang="en-US" dirty="0"/>
              <a:t>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A637DF9-26BA-F94F-A209-C23BFF8D85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2327" y="1800925"/>
            <a:ext cx="11407346" cy="4691950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DD168EA7-D3D7-7749-A044-DAC651351861}"/>
              </a:ext>
            </a:extLst>
          </p:cNvPr>
          <p:cNvSpPr/>
          <p:nvPr/>
        </p:nvSpPr>
        <p:spPr>
          <a:xfrm>
            <a:off x="6281057" y="2536370"/>
            <a:ext cx="533400" cy="58782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0263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6526041C-0483-2A4E-A15D-03400438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C. An indel in </a:t>
            </a:r>
            <a:r>
              <a:rPr lang="en-US" i="1" dirty="0" err="1"/>
              <a:t>xopK</a:t>
            </a:r>
            <a:r>
              <a:rPr lang="en-US" dirty="0"/>
              <a:t>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42C35D9-EF70-F14F-889B-8AA0703401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919" y="1943000"/>
            <a:ext cx="11331146" cy="4660608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B5B9E17D-BE81-C443-B00B-7A68C3DB00A0}"/>
              </a:ext>
            </a:extLst>
          </p:cNvPr>
          <p:cNvSpPr/>
          <p:nvPr/>
        </p:nvSpPr>
        <p:spPr>
          <a:xfrm>
            <a:off x="2993571" y="3685475"/>
            <a:ext cx="7826829" cy="58782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6126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6526041C-0483-2A4E-A15D-03400438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D. SNP in </a:t>
            </a:r>
            <a:r>
              <a:rPr lang="en-US" i="1" dirty="0" err="1"/>
              <a:t>xopAK</a:t>
            </a:r>
            <a:r>
              <a:rPr lang="en-US" dirty="0"/>
              <a:t>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B0188CA-AA2B-404C-9070-4F37AF51A0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719" y="1867935"/>
            <a:ext cx="11726562" cy="4823247"/>
          </a:xfrm>
          <a:prstGeom prst="rect">
            <a:avLst/>
          </a:prstGeom>
        </p:spPr>
      </p:pic>
      <p:sp>
        <p:nvSpPr>
          <p:cNvPr id="6" name="Oval 5">
            <a:extLst>
              <a:ext uri="{FF2B5EF4-FFF2-40B4-BE49-F238E27FC236}">
                <a16:creationId xmlns:a16="http://schemas.microsoft.com/office/drawing/2014/main" id="{9234FB57-5038-974B-8DD5-F02C7ED81130}"/>
              </a:ext>
            </a:extLst>
          </p:cNvPr>
          <p:cNvSpPr/>
          <p:nvPr/>
        </p:nvSpPr>
        <p:spPr>
          <a:xfrm>
            <a:off x="6531428" y="4147456"/>
            <a:ext cx="533400" cy="816430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4117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6526041C-0483-2A4E-A15D-03400438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E. SNP in </a:t>
            </a:r>
            <a:r>
              <a:rPr lang="en-US" i="1" dirty="0" err="1"/>
              <a:t>xopR</a:t>
            </a:r>
            <a:r>
              <a:rPr lang="en-US" dirty="0"/>
              <a:t>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3C29A6E-D34A-124B-827F-E8C7AD9697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4503" y="1944081"/>
            <a:ext cx="11059297" cy="4548794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5BF01532-A84D-D147-9EC2-DA91920DF08C}"/>
              </a:ext>
            </a:extLst>
          </p:cNvPr>
          <p:cNvSpPr/>
          <p:nvPr/>
        </p:nvSpPr>
        <p:spPr>
          <a:xfrm>
            <a:off x="5965371" y="2656113"/>
            <a:ext cx="533400" cy="58782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4141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6526041C-0483-2A4E-A15D-03400438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F. SNP in </a:t>
            </a:r>
            <a:r>
              <a:rPr lang="en-US" i="1" dirty="0" err="1"/>
              <a:t>xopX</a:t>
            </a:r>
            <a:r>
              <a:rPr lang="en-US" dirty="0"/>
              <a:t>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59D0812-5A68-404C-B793-B7F10A4F04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492" y="1688997"/>
            <a:ext cx="11521016" cy="4738704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A67993CA-D0DE-604D-B37B-90DAA1E40FA2}"/>
              </a:ext>
            </a:extLst>
          </p:cNvPr>
          <p:cNvSpPr/>
          <p:nvPr/>
        </p:nvSpPr>
        <p:spPr>
          <a:xfrm>
            <a:off x="6520542" y="2568245"/>
            <a:ext cx="533400" cy="2167041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7847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6526041C-0483-2A4E-A15D-03400438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G. Two of three SNPs in </a:t>
            </a:r>
            <a:r>
              <a:rPr lang="en-US" i="1" dirty="0"/>
              <a:t>xopZ1</a:t>
            </a:r>
            <a:r>
              <a:rPr lang="en-US" dirty="0"/>
              <a:t>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BBD6699-4D9F-9C41-8260-66CE559AF3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9100" y="1841484"/>
            <a:ext cx="11353800" cy="46699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11745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6526041C-0483-2A4E-A15D-034004387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3H. One of three SNPs in </a:t>
            </a:r>
            <a:r>
              <a:rPr lang="en-US" i="1" dirty="0"/>
              <a:t>xopZ1</a:t>
            </a:r>
            <a:r>
              <a:rPr lang="en-US" dirty="0"/>
              <a:t>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1F6C42F-9868-4346-80C7-45C1EE7384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848" y="1816443"/>
            <a:ext cx="11609957" cy="4775286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7A475BB2-8804-E149-85D6-5AA75EB30D98}"/>
              </a:ext>
            </a:extLst>
          </p:cNvPr>
          <p:cNvSpPr/>
          <p:nvPr/>
        </p:nvSpPr>
        <p:spPr>
          <a:xfrm>
            <a:off x="6237514" y="2841171"/>
            <a:ext cx="533400" cy="968829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618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</TotalTime>
  <Words>159</Words>
  <Application>Microsoft Office PowerPoint</Application>
  <PresentationFormat>Widescreen</PresentationFormat>
  <Paragraphs>16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8" baseType="lpstr">
      <vt:lpstr>Arial</vt:lpstr>
      <vt:lpstr>Calibri</vt:lpstr>
      <vt:lpstr>Calibri Light</vt:lpstr>
      <vt:lpstr>Office Theme</vt:lpstr>
      <vt:lpstr>Figures S3A to S3M show alignments of genomic sequence reads versus the complete reference genome sequence of Xanthomonas vasicola pv. musacearum NCPPB 4379 (GenBank: CP034655.1). Reads were aligned using BWA-mem and visualized using IGV.</vt:lpstr>
      <vt:lpstr>Supplementary Figure 3A. SNP in xopF1.</vt:lpstr>
      <vt:lpstr>Supplementary Figure 3B. SNP in xopK.</vt:lpstr>
      <vt:lpstr>Supplementary Figure 3C. An indel in xopK.</vt:lpstr>
      <vt:lpstr>Supplementary Figure 3D. SNP in xopAK.</vt:lpstr>
      <vt:lpstr>Supplementary Figure 3E. SNP in xopR.</vt:lpstr>
      <vt:lpstr>Supplementary Figure 3F. SNP in xopX.</vt:lpstr>
      <vt:lpstr>Supplementary Figure 3G. Two of three SNPs in xopZ1.</vt:lpstr>
      <vt:lpstr>Supplementary Figure 3H. One of three SNPs in xopZ1.</vt:lpstr>
      <vt:lpstr>Supplementary Figure 3I. A SNP in xopAE.</vt:lpstr>
      <vt:lpstr>Supplementary Figure 3J. A SNP in xopAF2.</vt:lpstr>
      <vt:lpstr>Supplementary Figure 3K. Two SNPs in xopAG.</vt:lpstr>
      <vt:lpstr>Supplementary Figure 3L. Four of five SNPs in xopP.</vt:lpstr>
      <vt:lpstr>Supplementary Figure 3M. One of five SNPs in xopP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le X. SNP in xopF1.</dc:title>
  <dc:creator>Studholme, David</dc:creator>
  <cp:lastModifiedBy>Nakato, Valentine (IITA)</cp:lastModifiedBy>
  <cp:revision>10</cp:revision>
  <dcterms:created xsi:type="dcterms:W3CDTF">2020-04-27T20:45:07Z</dcterms:created>
  <dcterms:modified xsi:type="dcterms:W3CDTF">2020-05-05T14:44:46Z</dcterms:modified>
</cp:coreProperties>
</file>